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6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125" d="100"/>
          <a:sy n="125" d="100"/>
        </p:scale>
        <p:origin x="878" y="-19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97D19265-A1FD-4264-B668-D6A345F72D12}"/>
              </a:ext>
            </a:extLst>
          </p:cNvPr>
          <p:cNvSpPr/>
          <p:nvPr/>
        </p:nvSpPr>
        <p:spPr>
          <a:xfrm>
            <a:off x="731520" y="520475"/>
            <a:ext cx="5409918" cy="3759251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B0934E6-FA1F-4C67-B730-821166A2867B}"/>
              </a:ext>
            </a:extLst>
          </p:cNvPr>
          <p:cNvSpPr txBox="1"/>
          <p:nvPr/>
        </p:nvSpPr>
        <p:spPr>
          <a:xfrm>
            <a:off x="731520" y="4573543"/>
            <a:ext cx="54099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solidFill>
                  <a:srgbClr val="0E101A"/>
                </a:solidFill>
                <a:effectLst/>
              </a:rPr>
              <a:t>Supplementary Figure 17 |</a:t>
            </a:r>
            <a:r>
              <a:rPr lang="en-US" sz="1200" dirty="0"/>
              <a:t> Radar diagrams of </a:t>
            </a:r>
            <a:r>
              <a:rPr lang="en-US" sz="1200" i="1" dirty="0">
                <a:solidFill>
                  <a:srgbClr val="0E101A"/>
                </a:solidFill>
                <a:effectLst/>
              </a:rPr>
              <a:t>MKK2 </a:t>
            </a:r>
            <a:r>
              <a:rPr lang="en-US" sz="1200" dirty="0"/>
              <a:t>expressions, stem lengths, and -diameters from WT and survived recovered events after NaCl treatment. No significant differences in </a:t>
            </a:r>
            <a:r>
              <a:rPr lang="en-US" sz="1200" i="1" dirty="0">
                <a:solidFill>
                  <a:srgbClr val="0E101A"/>
                </a:solidFill>
                <a:effectLst/>
              </a:rPr>
              <a:t>MKK2</a:t>
            </a:r>
            <a:r>
              <a:rPr lang="en-US" sz="1200" dirty="0"/>
              <a:t> expressions and phenotypic changes before and after salt stress between WT and survived recovered events confirmed the exact genetic engineering induced by efficient HDR to keep </a:t>
            </a:r>
            <a:r>
              <a:rPr lang="en-US" sz="1200" i="1" dirty="0">
                <a:solidFill>
                  <a:srgbClr val="0E101A"/>
                </a:solidFill>
                <a:effectLst/>
              </a:rPr>
              <a:t>MKK2 </a:t>
            </a:r>
            <a:r>
              <a:rPr lang="en-US" sz="1200" dirty="0"/>
              <a:t>exons arrangement.</a:t>
            </a:r>
            <a:endParaRPr lang="en-US" sz="12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2B9CD6B-A0B6-4EF9-BB3D-0474AD5C99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8019" y="613217"/>
            <a:ext cx="2397381" cy="181989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7C14E37-4796-4915-A772-6C811A8053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8019" y="2401181"/>
            <a:ext cx="2397381" cy="181989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9A612F5-2CFB-4139-989B-55E1AD4D0B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167" y="573024"/>
            <a:ext cx="4572396" cy="3467209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67911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61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6</cp:revision>
  <dcterms:created xsi:type="dcterms:W3CDTF">2022-05-10T05:11:22Z</dcterms:created>
  <dcterms:modified xsi:type="dcterms:W3CDTF">2022-05-11T09:28:29Z</dcterms:modified>
</cp:coreProperties>
</file>